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315" r:id="rId2"/>
    <p:sldId id="313" r:id="rId3"/>
    <p:sldId id="301" r:id="rId4"/>
    <p:sldId id="295" r:id="rId5"/>
    <p:sldId id="296" r:id="rId6"/>
    <p:sldId id="298" r:id="rId7"/>
    <p:sldId id="314" r:id="rId8"/>
  </p:sldIdLst>
  <p:sldSz cx="12192000" cy="6858000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7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10" Type="http://schemas.openxmlformats.org/officeDocument/2006/relationships/presProps" Target="presProps.xml"/>
   <Relationship Id="rId11" Type="http://schemas.openxmlformats.org/officeDocument/2006/relationships/viewProps" Target="viewProps.xml"/>
   <Relationship Id="rId12" Type="http://schemas.openxmlformats.org/officeDocument/2006/relationships/theme" Target="theme/theme1.xml"/>
   <Relationship Id="rId13" Type="http://schemas.openxmlformats.org/officeDocument/2006/relationships/tableStyles" Target="tableStyles.xml"/>
   <Relationship Id="rId2" Type="http://schemas.openxmlformats.org/officeDocument/2006/relationships/slide" Target="slides/slide1.xml"/>
   <Relationship Id="rId3" Type="http://schemas.openxmlformats.org/officeDocument/2006/relationships/slide" Target="slides/slide2.xml"/>
   <Relationship Id="rId4" Type="http://schemas.openxmlformats.org/officeDocument/2006/relationships/slide" Target="slides/slide3.xml"/>
   <Relationship Id="rId5" Type="http://schemas.openxmlformats.org/officeDocument/2006/relationships/slide" Target="slides/slide4.xml"/>
   <Relationship Id="rId6" Type="http://schemas.openxmlformats.org/officeDocument/2006/relationships/slide" Target="slides/slide5.xml"/>
   <Relationship Id="rId7" Type="http://schemas.openxmlformats.org/officeDocument/2006/relationships/slide" Target="slides/slide6.xml"/>
   <Relationship Id="rId8" Type="http://schemas.openxmlformats.org/officeDocument/2006/relationships/slide" Target="slides/slide7.xml"/>
   <Relationship Id="rId9" Type="http://schemas.openxmlformats.org/officeDocument/2006/relationships/notesMaster" Target="notesMasters/notesMaster1.xml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0A05C050-F66C-4892-941E-9CAEFE974DDD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92BCA241-9BD0-4D86-8B70-A23BDFD1C26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46973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3.xml"/>
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Median telomerase expression count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2BCA241-9BD0-4D86-8B70-A23BDFD1C26C}" type="slidenum">
              <a:rPr lang="en-US" smtClean="0"/>
              <a:pPr>
                <a:defRPr/>
              </a:pPr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193403"/>
      </p:ext>
    </p:extLst>
  </p:cSld>
  <p:clrMapOvr>
    <a:masterClrMapping/>
  </p:clrMapOvr>
</p:note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E0E783-AE49-43C8-A4B0-351AA3C3D11E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776244-5D45-4A20-BAB5-7499C4A8B66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595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9188C2-E227-47A6-856D-8B2C0713C525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7B07F6-A9F0-4E13-B2DF-862148B5A76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889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FF85E4-A9AA-4828-8B64-76210CC932ED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1D678D-A6CD-4099-9B87-B186368470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803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C5968F-79EE-480B-9DA4-2A3C350185FE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3D5EBC-CC05-43D6-A405-6B686A576B0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743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866660-4879-499A-ADE5-EE84E4AA7C4C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15437F-B030-41F3-9414-C095EDC4F22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854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235D84-29EF-4DEF-B123-A115C268A0F6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2008AC0-6883-458A-BF2D-0F433892784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151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25A078-9301-460C-9425-500957A0A83E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B45847-9D15-4D79-9610-289C49FD579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83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59BB98-7B16-49B3-B328-CFCBB3ABCC0B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19286D-72F0-4703-8272-E9E8EFDDECB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62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685B9C-417C-484D-8FA1-96AB639AF7F8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BF692A-1297-4797-9762-3ED20D5364E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376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3F74A3-91B6-4EDD-AF13-1189393C20D5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E6A3A2-A2F5-406C-9A87-2805D04240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083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DE7159-4FF0-4C7A-9C15-F359FB2D2649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698DA5-8207-43E6-9B71-8CDA2603F3B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999456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D6747FCE-ABBB-4367-A686-CB30C0E3D4CB}" type="datetimeFigureOut">
              <a:rPr lang="en-US"/>
              <a:pPr>
                <a:defRPr/>
              </a:pPr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C7FF1C56-4C51-4C41-85D5-77040922DA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image" Target="../media/image1.TIF"/>
</Relationships>
</file>

<file path=ppt/slides/_rels/slide3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notesSlide" Target="../notesSlides/notesSlide1.xml"/>
   <Relationship Id="rId3" Type="http://schemas.openxmlformats.org/officeDocument/2006/relationships/image" Target="../media/image2.TIF"/>
</Relationships>
</file>

<file path=ppt/slides/_rels/slide4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image" Target="../media/image3.TIF"/>
</Relationships>
</file>

<file path=ppt/slides/_rels/slide5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image" Target="../media/image4.TIF"/>
</Relationships>
</file>

<file path=ppt/slides/_rels/slide6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image" Target="../media/image5.TIF"/>
</Relationships>
</file>

<file path=ppt/slides/_rels/slide7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image" Target="../media/image6.TIF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41192" y="1619316"/>
            <a:ext cx="11505063" cy="29290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algn="ctr">
              <a:spcBef>
                <a:spcPts val="0"/>
              </a:spcBef>
              <a:spcAft>
                <a:spcPts val="1000"/>
              </a:spcAft>
            </a:pPr>
            <a:r>
              <a:rPr lang="en-US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6.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patiotemporal dynamics of </a:t>
            </a:r>
            <a:r>
              <a:rPr lang="en-US" sz="16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RT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 and individual </a:t>
            </a:r>
            <a:r>
              <a:rPr lang="en-US" sz="16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RT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+) cells prevalence in human preimplantation embryos. </a:t>
            </a:r>
          </a:p>
          <a:p>
            <a:pPr marL="0" marR="0" algn="ctr">
              <a:spcBef>
                <a:spcPts val="0"/>
              </a:spcBef>
              <a:spcAft>
                <a:spcPts val="1000"/>
              </a:spcAft>
            </a:pPr>
            <a:r>
              <a:rPr lang="en-US" sz="16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RT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RNA expression patterns were evaluated in 1,529 individual human embryonic cells recovered from different stages of preimplantation embryogenesis and assigned to different developmental lineages based on their gene expression profiles [Petropoulos et al., 2016]. These analyses demonstrate that </a:t>
            </a:r>
            <a:r>
              <a:rPr lang="en-US" sz="16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RT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+) cells could be observed among all lineages and are readily detectable as early as at the E3-E4 stages followed by the expansion during the E5 stage coincidently with blastocyst formation (A; B; E; F). E5 pre-lineage cells manifest significantly increased levels of </a:t>
            </a:r>
            <a:r>
              <a:rPr lang="en-US" sz="16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RT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RNA expression compared to EPI, PE, and TE lineages (C; D). The second peak of </a:t>
            </a:r>
            <a:r>
              <a:rPr lang="en-US" sz="16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RT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ctivity was observed at the E6 (B; E) in all three major lineages created during human preimplantation embryonic development. E5.early cell population has the highest level of </a:t>
            </a:r>
            <a:r>
              <a:rPr lang="en-US" sz="16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RT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RNA expression and contains the largest percentage of </a:t>
            </a:r>
            <a:r>
              <a:rPr lang="en-US" sz="16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RT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+) cells compared to other stages of human preimplantation embryonic development (B; F). </a:t>
            </a:r>
            <a:endParaRPr lang="en-US" sz="16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26164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83951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6591870" y="6100549"/>
            <a:ext cx="1078172" cy="4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2388359" y="6096112"/>
            <a:ext cx="3234520" cy="50156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 rot="16200000">
            <a:off x="-805430" y="3244334"/>
            <a:ext cx="4435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MEDIAN TELOMERASE EXPRESSION COUNTS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0601910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6639932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7674201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7030217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3971499" y="5786651"/>
            <a:ext cx="3862316" cy="4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0" y="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27551207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1</TotalTime>
  <Words>205</Words>
  <Application>Microsoft Office PowerPoint</Application>
  <PresentationFormat>Widescreen</PresentationFormat>
  <Paragraphs>11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